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7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그룹 18"/>
          <p:cNvGrpSpPr/>
          <p:nvPr/>
        </p:nvGrpSpPr>
        <p:grpSpPr>
          <a:xfrm>
            <a:off x="594892" y="1124110"/>
            <a:ext cx="11147402" cy="3973667"/>
            <a:chOff x="594892" y="1124110"/>
            <a:chExt cx="11147402" cy="3973667"/>
          </a:xfrm>
        </p:grpSpPr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56419" y="1124110"/>
              <a:ext cx="5487468" cy="3438525"/>
            </a:xfrm>
            <a:prstGeom prst="rect">
              <a:avLst/>
            </a:prstGeom>
          </p:spPr>
        </p:pic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43888" y="1154182"/>
              <a:ext cx="5198405" cy="3419475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914399" y="4501739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45222" y="4790000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직선 연결선 23"/>
            <p:cNvCxnSpPr/>
            <p:nvPr/>
          </p:nvCxnSpPr>
          <p:spPr>
            <a:xfrm>
              <a:off x="1765029" y="481102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/>
            <p:cNvCxnSpPr/>
            <p:nvPr/>
          </p:nvCxnSpPr>
          <p:spPr>
            <a:xfrm>
              <a:off x="2957953" y="481102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/>
            <p:nvPr/>
          </p:nvCxnSpPr>
          <p:spPr>
            <a:xfrm>
              <a:off x="4186009" y="481102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5378933" y="4811020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6612480" y="481102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7646095" y="481205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8659768" y="4813081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9672362" y="481102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10695230" y="481102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 rot="16200000">
              <a:off x="204227" y="2678107"/>
              <a:ext cx="1119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r>
                <a:rPr lang="en-US" altLang="ko-KR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, ppm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15495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4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5:57Z</dcterms:modified>
</cp:coreProperties>
</file>